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6E7BAF-7F46-40EF-B874-17D940128539}" v="2" dt="2024-11-10T18:21:03.9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159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hosh, Souvik" userId="eecea02d-3ead-4d19-9bc6-c58aca595acd" providerId="ADAL" clId="{3E6E7BAF-7F46-40EF-B874-17D940128539}"/>
    <pc:docChg chg="addSld modSld modMainMaster">
      <pc:chgData name="Ghosh, Souvik" userId="eecea02d-3ead-4d19-9bc6-c58aca595acd" providerId="ADAL" clId="{3E6E7BAF-7F46-40EF-B874-17D940128539}" dt="2024-11-10T18:21:09.542" v="16" actId="1076"/>
      <pc:docMkLst>
        <pc:docMk/>
      </pc:docMkLst>
      <pc:sldChg chg="addSp modSp new mod">
        <pc:chgData name="Ghosh, Souvik" userId="eecea02d-3ead-4d19-9bc6-c58aca595acd" providerId="ADAL" clId="{3E6E7BAF-7F46-40EF-B874-17D940128539}" dt="2024-11-10T18:21:09.542" v="16" actId="1076"/>
        <pc:sldMkLst>
          <pc:docMk/>
          <pc:sldMk cId="704898727" sldId="256"/>
        </pc:sldMkLst>
        <pc:spChg chg="add mod">
          <ac:chgData name="Ghosh, Souvik" userId="eecea02d-3ead-4d19-9bc6-c58aca595acd" providerId="ADAL" clId="{3E6E7BAF-7F46-40EF-B874-17D940128539}" dt="2024-11-10T18:20:52.320" v="11" actId="1076"/>
          <ac:spMkLst>
            <pc:docMk/>
            <pc:sldMk cId="704898727" sldId="256"/>
            <ac:spMk id="3" creationId="{5E702E80-18A7-EF15-FCD6-00C5882657FA}"/>
          </ac:spMkLst>
        </pc:spChg>
        <pc:picChg chg="add mod">
          <ac:chgData name="Ghosh, Souvik" userId="eecea02d-3ead-4d19-9bc6-c58aca595acd" providerId="ADAL" clId="{3E6E7BAF-7F46-40EF-B874-17D940128539}" dt="2024-11-10T18:21:09.542" v="16" actId="1076"/>
          <ac:picMkLst>
            <pc:docMk/>
            <pc:sldMk cId="704898727" sldId="256"/>
            <ac:picMk id="5" creationId="{96B58289-41E6-55B1-6D54-7D3BCE23D15B}"/>
          </ac:picMkLst>
        </pc:picChg>
      </pc:sldChg>
      <pc:sldMasterChg chg="modSp modSldLayout">
        <pc:chgData name="Ghosh, Souvik" userId="eecea02d-3ead-4d19-9bc6-c58aca595acd" providerId="ADAL" clId="{3E6E7BAF-7F46-40EF-B874-17D940128539}" dt="2024-11-10T18:20:10.744" v="0"/>
        <pc:sldMasterMkLst>
          <pc:docMk/>
          <pc:sldMasterMk cId="2151654687" sldId="2147483648"/>
        </pc:sldMasterMkLst>
        <pc:spChg chg="mod">
          <ac:chgData name="Ghosh, Souvik" userId="eecea02d-3ead-4d19-9bc6-c58aca595acd" providerId="ADAL" clId="{3E6E7BAF-7F46-40EF-B874-17D940128539}" dt="2024-11-10T18:20:10.744" v="0"/>
          <ac:spMkLst>
            <pc:docMk/>
            <pc:sldMasterMk cId="2151654687" sldId="2147483648"/>
            <ac:spMk id="2" creationId="{062B6B33-2E8B-6A17-CD66-E617E7EC0193}"/>
          </ac:spMkLst>
        </pc:spChg>
        <pc:spChg chg="mod">
          <ac:chgData name="Ghosh, Souvik" userId="eecea02d-3ead-4d19-9bc6-c58aca595acd" providerId="ADAL" clId="{3E6E7BAF-7F46-40EF-B874-17D940128539}" dt="2024-11-10T18:20:10.744" v="0"/>
          <ac:spMkLst>
            <pc:docMk/>
            <pc:sldMasterMk cId="2151654687" sldId="2147483648"/>
            <ac:spMk id="3" creationId="{2715E616-8998-9007-E2A7-D52FF90AFD40}"/>
          </ac:spMkLst>
        </pc:spChg>
        <pc:spChg chg="mod">
          <ac:chgData name="Ghosh, Souvik" userId="eecea02d-3ead-4d19-9bc6-c58aca595acd" providerId="ADAL" clId="{3E6E7BAF-7F46-40EF-B874-17D940128539}" dt="2024-11-10T18:20:10.744" v="0"/>
          <ac:spMkLst>
            <pc:docMk/>
            <pc:sldMasterMk cId="2151654687" sldId="2147483648"/>
            <ac:spMk id="4" creationId="{324F6636-167F-D0E8-E281-87A7C1D6C6F5}"/>
          </ac:spMkLst>
        </pc:spChg>
        <pc:spChg chg="mod">
          <ac:chgData name="Ghosh, Souvik" userId="eecea02d-3ead-4d19-9bc6-c58aca595acd" providerId="ADAL" clId="{3E6E7BAF-7F46-40EF-B874-17D940128539}" dt="2024-11-10T18:20:10.744" v="0"/>
          <ac:spMkLst>
            <pc:docMk/>
            <pc:sldMasterMk cId="2151654687" sldId="2147483648"/>
            <ac:spMk id="5" creationId="{FD0F1B5C-FF44-9578-AE75-A73321A6E521}"/>
          </ac:spMkLst>
        </pc:spChg>
        <pc:spChg chg="mod">
          <ac:chgData name="Ghosh, Souvik" userId="eecea02d-3ead-4d19-9bc6-c58aca595acd" providerId="ADAL" clId="{3E6E7BAF-7F46-40EF-B874-17D940128539}" dt="2024-11-10T18:20:10.744" v="0"/>
          <ac:spMkLst>
            <pc:docMk/>
            <pc:sldMasterMk cId="2151654687" sldId="2147483648"/>
            <ac:spMk id="6" creationId="{32876014-B773-483D-059A-723B96B06C64}"/>
          </ac:spMkLst>
        </pc:sp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3166609801" sldId="2147483649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3166609801" sldId="2147483649"/>
              <ac:spMk id="2" creationId="{5FAE757B-4E80-67D1-323E-06DB6CF94A19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3166609801" sldId="2147483649"/>
              <ac:spMk id="3" creationId="{41D96207-93A2-2384-F09B-6A7412CD57F1}"/>
            </ac:spMkLst>
          </pc:spChg>
        </pc:sldLayout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1168365761" sldId="2147483651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1168365761" sldId="2147483651"/>
              <ac:spMk id="2" creationId="{C7ABDB51-06E5-84E4-97D9-1ED0A8E63DEE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1168365761" sldId="2147483651"/>
              <ac:spMk id="3" creationId="{62B86A72-4046-2133-A69E-1C513D3D9D9D}"/>
            </ac:spMkLst>
          </pc:spChg>
        </pc:sldLayout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376867646" sldId="2147483652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376867646" sldId="2147483652"/>
              <ac:spMk id="3" creationId="{B30672D5-D0C9-F23D-1DA4-AF9410C2BDE5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376867646" sldId="2147483652"/>
              <ac:spMk id="4" creationId="{00B6B797-858D-17E3-D6D6-3BA5538D0072}"/>
            </ac:spMkLst>
          </pc:spChg>
        </pc:sldLayout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2317763814" sldId="2147483653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317763814" sldId="2147483653"/>
              <ac:spMk id="2" creationId="{39506B71-737F-4E6E-36E2-BBE0B76B3112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317763814" sldId="2147483653"/>
              <ac:spMk id="3" creationId="{074FACEE-E414-F21E-EAA2-6B35CFE26FA5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317763814" sldId="2147483653"/>
              <ac:spMk id="4" creationId="{8F64F25D-403E-39FC-7D9A-9BA74594FABE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317763814" sldId="2147483653"/>
              <ac:spMk id="5" creationId="{11EA8281-1066-0EE2-77EE-6182616D6C74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317763814" sldId="2147483653"/>
              <ac:spMk id="6" creationId="{3966E2C7-2FAC-B5AE-66BA-2F6E72BCA1A7}"/>
            </ac:spMkLst>
          </pc:spChg>
        </pc:sldLayout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4096218617" sldId="2147483656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4096218617" sldId="2147483656"/>
              <ac:spMk id="2" creationId="{67AB4D77-C520-DA56-D627-43B5C69CB49B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4096218617" sldId="2147483656"/>
              <ac:spMk id="3" creationId="{B3BB6AED-648E-BDAE-53CD-E52340BC048A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4096218617" sldId="2147483656"/>
              <ac:spMk id="4" creationId="{E629D327-1015-9448-90D9-D610A293B495}"/>
            </ac:spMkLst>
          </pc:spChg>
        </pc:sldLayout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2837083582" sldId="2147483657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837083582" sldId="2147483657"/>
              <ac:spMk id="2" creationId="{23A18847-3CDD-D132-FDD5-C2E24FD872AA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837083582" sldId="2147483657"/>
              <ac:spMk id="3" creationId="{2AA9721B-3595-A154-ECE2-50921A578993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2837083582" sldId="2147483657"/>
              <ac:spMk id="4" creationId="{255774AC-0EDE-F18D-F798-DBC9E62D4102}"/>
            </ac:spMkLst>
          </pc:spChg>
        </pc:sldLayoutChg>
        <pc:sldLayoutChg chg="modSp">
          <pc:chgData name="Ghosh, Souvik" userId="eecea02d-3ead-4d19-9bc6-c58aca595acd" providerId="ADAL" clId="{3E6E7BAF-7F46-40EF-B874-17D940128539}" dt="2024-11-10T18:20:10.744" v="0"/>
          <pc:sldLayoutMkLst>
            <pc:docMk/>
            <pc:sldMasterMk cId="2151654687" sldId="2147483648"/>
            <pc:sldLayoutMk cId="720400738" sldId="2147483659"/>
          </pc:sldLayoutMkLst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720400738" sldId="2147483659"/>
              <ac:spMk id="2" creationId="{9A5D5EB8-5560-8A3F-2F18-2C225896C838}"/>
            </ac:spMkLst>
          </pc:spChg>
          <pc:spChg chg="mod">
            <ac:chgData name="Ghosh, Souvik" userId="eecea02d-3ead-4d19-9bc6-c58aca595acd" providerId="ADAL" clId="{3E6E7BAF-7F46-40EF-B874-17D940128539}" dt="2024-11-10T18:20:10.744" v="0"/>
            <ac:spMkLst>
              <pc:docMk/>
              <pc:sldMasterMk cId="2151654687" sldId="2147483648"/>
              <pc:sldLayoutMk cId="720400738" sldId="2147483659"/>
              <ac:spMk id="3" creationId="{88B5CE0E-F741-2968-934C-8F0641D7B0BE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E757B-4E80-67D1-323E-06DB6CF94A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D96207-93A2-2384-F09B-6A7412CD57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31EA78-32AC-C8BE-7939-12AA33213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539C9-E99C-D72A-F430-028DF2A22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FECAF-6D2A-26EF-63A2-4F5505890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609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030E26-708F-32EB-20BE-8548038BD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60A13F-519E-0881-0779-38ABA4361E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390A1-808F-3A5D-083D-3D0F80B07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7489D0-28FB-4572-6CEA-00448690C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12B511-5768-2C81-87BA-D64DB2A54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357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5D5EB8-5560-8A3F-2F18-2C225896C8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B5CE0E-F741-2968-934C-8F0641D7B0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D04D49-1A25-45F3-A7C6-052DDDAC1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177B35-8D5D-9872-E496-B85215F01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00A71-22E5-31C0-715C-0449AEB13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400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89122F-2CC5-6C2A-DAE4-86D3C3C48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A6B26F-6C4F-281F-3B83-81F8DF21DD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87B482-7C85-00C6-3200-C7B3B1940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1FF45F-F309-4D86-E9B3-1240DA389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6FFFEC-C542-6EB1-C2E5-314B7E21C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111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BDB51-06E5-84E4-97D9-1ED0A8E63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B86A72-4046-2133-A69E-1C513D3D9D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F5B5C-51FF-FD88-5CAD-227FD0CAC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8D0B5E-FF4E-CB0F-BA2F-FFA385088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9CCE57-A1BF-8402-D097-C30B2A305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365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E63E14-DED1-EADF-7118-CFA222A91B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0672D5-D0C9-F23D-1DA4-AF9410C2BD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B6B797-858D-17E3-D6D6-3BA5538D00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7E22F7-AE57-F0C0-85A0-C59E4B34A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967184-1A00-DA27-620A-98CC798C0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4E8000-7E8E-D039-7B01-BD1B8BDBF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6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506B71-737F-4E6E-36E2-BBE0B76B31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4FACEE-E414-F21E-EAA2-6B35CFE26F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64F25D-403E-39FC-7D9A-9BA74594F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EA8281-1066-0EE2-77EE-6182616D6C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66E2C7-2FAC-B5AE-66BA-2F6E72BCA1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2F2D7F-0CC2-7920-7139-0429592B4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68DFBB-F72E-570B-861F-B5E1FB1A0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AB2162-C9A3-CB16-8E59-F89BA51B0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763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A4B537-7EB0-1743-A2B2-EC1B91FB88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7A2427-B21D-64FB-1EB2-4CE3DA8EF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8BFBEE-846C-49CB-C803-B22C40725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6D11DC-8B76-F730-2A3C-B8F29448F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575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2E6731-F151-6685-AC0A-6014BEAA2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4312FD-3A02-EB4A-5224-46E331102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626CBD-B3F1-0D90-371A-00AB594D9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47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AB4D77-C520-DA56-D627-43B5C69CB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BB6AED-648E-BDAE-53CD-E52340BC04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29D327-1015-9448-90D9-D610A293B4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05C315-9E0E-9CCD-F3A3-224E09E69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5DEE1D-C11E-9B41-F630-8E2C80546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C4B1E8-54AE-DD89-EB86-8BD84D6FC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218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18847-3CDD-D132-FDD5-C2E24FD87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A9721B-3595-A154-ECE2-50921A5789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5774AC-0EDE-F18D-F798-DBC9E62D41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949E5-E42E-F964-C57A-CADEBC812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899685-4C1A-5D93-7394-82CFF6961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B00050-7AC0-69BF-4014-44B677830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083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2B6B33-2E8B-6A17-CD66-E617E7EC0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15E616-8998-9007-E2A7-D52FF90AF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4F6636-167F-D0E8-E281-87A7C1D6C6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DC4703-8A9F-4E1F-9287-AF2C3F9E0D3D}" type="datetimeFigureOut">
              <a:rPr lang="en-US" smtClean="0"/>
              <a:t>11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0F1B5C-FF44-9578-AE75-A73321A6E5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6014-B773-483D-059A-723B96B06C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FF1481-56CF-49D9-95C3-48B8B6EBA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654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E702E80-18A7-EF15-FCD6-00C5882657FA}"/>
              </a:ext>
            </a:extLst>
          </p:cNvPr>
          <p:cNvSpPr txBox="1"/>
          <p:nvPr/>
        </p:nvSpPr>
        <p:spPr>
          <a:xfrm>
            <a:off x="91440" y="94179"/>
            <a:ext cx="89611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Supplementary figure S2. </a:t>
            </a:r>
            <a:r>
              <a:rPr lang="en-US" sz="1200" dirty="0">
                <a:latin typeface="Palatino Linotype" panose="02040502050505030304" pitchFamily="18" charset="0"/>
              </a:rPr>
              <a:t>Map of the Caribbean Lesser Antilles showing the geographical locations of St. Kitts and Martinique (shown with a red and a dark teal arrow, respectively). The map was adapted from https://ian.macky.net/pat/map/lant/lantblu.gif (accessed on 20 October 2024) under a PD (public domain) license. </a:t>
            </a:r>
          </a:p>
        </p:txBody>
      </p:sp>
      <p:pic>
        <p:nvPicPr>
          <p:cNvPr id="5" name="Picture 4" descr="A map of the caribbean islands&#10;&#10;Description automatically generated">
            <a:extLst>
              <a:ext uri="{FF2B5EF4-FFF2-40B4-BE49-F238E27FC236}">
                <a16:creationId xmlns:a16="http://schemas.microsoft.com/office/drawing/2014/main" id="{96B58289-41E6-55B1-6D54-7D3BCE23D1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0800" y="949960"/>
            <a:ext cx="6762403" cy="5193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89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hosh, Souvik</dc:creator>
  <cp:lastModifiedBy>Ghosh, Souvik</cp:lastModifiedBy>
  <cp:revision>1</cp:revision>
  <dcterms:created xsi:type="dcterms:W3CDTF">2024-11-10T18:19:58Z</dcterms:created>
  <dcterms:modified xsi:type="dcterms:W3CDTF">2024-11-10T18:21:10Z</dcterms:modified>
</cp:coreProperties>
</file>